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1" d="100"/>
          <a:sy n="71" d="100"/>
        </p:scale>
        <p:origin x="69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9850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07098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95551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36014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803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34840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4519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4840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3751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9257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9364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842F8F-9046-4A14-9B9D-89E3C210D5DC}" type="datetimeFigureOut">
              <a:rPr lang="en-GB" smtClean="0"/>
              <a:t>09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FCAB8-E4F5-4F05-8408-8C2F7A23564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5280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218940" y="90153"/>
            <a:ext cx="11973059" cy="103030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/>
            <a:r>
              <a:rPr lang="en-US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NJ-tree &amp; PCA between 271 </a:t>
            </a:r>
            <a:r>
              <a:rPr lang="en-US" sz="3200" i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Ipomoea </a:t>
            </a:r>
            <a:r>
              <a:rPr lang="en-US" sz="3200" i="1" dirty="0" err="1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batatas</a:t>
            </a:r>
            <a:r>
              <a:rPr lang="en-US" sz="3200" i="1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 </a:t>
            </a:r>
            <a:r>
              <a:rPr lang="en-GB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accessions </a:t>
            </a:r>
            <a:r>
              <a:rPr lang="en-US" sz="3200" dirty="0">
                <a:solidFill>
                  <a:srgbClr val="0070C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computed with 7,591  polymorphic  SNPs based on regions</a:t>
            </a:r>
            <a:endParaRPr lang="en-GB" sz="3200" dirty="0">
              <a:solidFill>
                <a:srgbClr val="FF0000"/>
              </a:solidFill>
              <a:latin typeface="Arial Narrow" panose="020B060602020203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5342198" y="5817936"/>
            <a:ext cx="1356718" cy="92333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 Narrow" panose="020B0606020202030204" pitchFamily="34" charset="0"/>
                <a:cs typeface="Arial" panose="020B0604020202020204" pitchFamily="34" charset="0"/>
              </a:rPr>
              <a:t>East Africa </a:t>
            </a:r>
          </a:p>
          <a:p>
            <a:r>
              <a:rPr lang="fr-FR" b="1" dirty="0">
                <a:solidFill>
                  <a:srgbClr val="FFFF00"/>
                </a:solidFill>
              </a:rPr>
              <a:t>South </a:t>
            </a:r>
            <a:r>
              <a:rPr lang="en-US" b="1" dirty="0">
                <a:solidFill>
                  <a:srgbClr val="FFFF00"/>
                </a:solidFill>
              </a:rPr>
              <a:t>Africa</a:t>
            </a:r>
          </a:p>
          <a:p>
            <a:r>
              <a:rPr lang="en-US" b="1" dirty="0">
                <a:solidFill>
                  <a:srgbClr val="0000FF"/>
                </a:solidFill>
              </a:rPr>
              <a:t>West Africa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496B5C5-8D94-F73E-D1C5-AE738BEC80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6246" y="1766406"/>
            <a:ext cx="3780567" cy="3545182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2FFD898-16DE-9701-09C3-17980CF4C69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0557" y="1510873"/>
            <a:ext cx="4707636" cy="38007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1503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udarnaud</dc:creator>
  <cp:lastModifiedBy>Mahaman Mourtala Issa Zakari</cp:lastModifiedBy>
  <cp:revision>2</cp:revision>
  <dcterms:created xsi:type="dcterms:W3CDTF">2023-01-02T11:43:05Z</dcterms:created>
  <dcterms:modified xsi:type="dcterms:W3CDTF">2024-10-09T18:25:59Z</dcterms:modified>
</cp:coreProperties>
</file>